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A3A3F9D-8739-4299-B3AA-087EC905EA79}" v="5" dt="2025-08-30T17:49:32.2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felipe buitrago" userId="09ce315a97466b30" providerId="LiveId" clId="{CA3A3F9D-8739-4299-B3AA-087EC905EA79}"/>
    <pc:docChg chg="undo custSel delSld modSld">
      <pc:chgData name="daniel felipe buitrago" userId="09ce315a97466b30" providerId="LiveId" clId="{CA3A3F9D-8739-4299-B3AA-087EC905EA79}" dt="2025-08-30T21:47:19.202" v="177" actId="2696"/>
      <pc:docMkLst>
        <pc:docMk/>
      </pc:docMkLst>
      <pc:sldChg chg="del">
        <pc:chgData name="daniel felipe buitrago" userId="09ce315a97466b30" providerId="LiveId" clId="{CA3A3F9D-8739-4299-B3AA-087EC905EA79}" dt="2025-08-30T21:47:19.202" v="177" actId="2696"/>
        <pc:sldMkLst>
          <pc:docMk/>
          <pc:sldMk cId="4091204039" sldId="256"/>
        </pc:sldMkLst>
      </pc:sldChg>
      <pc:sldChg chg="addSp delSp modSp mod">
        <pc:chgData name="daniel felipe buitrago" userId="09ce315a97466b30" providerId="LiveId" clId="{CA3A3F9D-8739-4299-B3AA-087EC905EA79}" dt="2025-08-30T17:57:12.126" v="176" actId="478"/>
        <pc:sldMkLst>
          <pc:docMk/>
          <pc:sldMk cId="644688964" sldId="257"/>
        </pc:sldMkLst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2" creationId="{DC87F11D-B1F4-72DD-3192-539F1D391036}"/>
          </ac:spMkLst>
        </pc:spChg>
        <pc:spChg chg="mod">
          <ac:chgData name="daniel felipe buitrago" userId="09ce315a97466b30" providerId="LiveId" clId="{CA3A3F9D-8739-4299-B3AA-087EC905EA79}" dt="2025-08-29T21:37:08.577" v="11" actId="14100"/>
          <ac:spMkLst>
            <pc:docMk/>
            <pc:sldMk cId="644688964" sldId="257"/>
            <ac:spMk id="8" creationId="{245A3B96-1EEE-2989-5FD0-042E1BD2939D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9" creationId="{8C620ABD-5E77-6D14-A1E9-0C266D84C06D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10" creationId="{00000000-0000-0000-0000-000000000000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12" creationId="{00000000-0000-0000-0000-000000000000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13" creationId="{00000000-0000-0000-0000-000000000000}"/>
          </ac:spMkLst>
        </pc:spChg>
        <pc:spChg chg="mod">
          <ac:chgData name="daniel felipe buitrago" userId="09ce315a97466b30" providerId="LiveId" clId="{CA3A3F9D-8739-4299-B3AA-087EC905EA79}" dt="2025-08-30T17:46:47.837" v="114" actId="1076"/>
          <ac:spMkLst>
            <pc:docMk/>
            <pc:sldMk cId="644688964" sldId="257"/>
            <ac:spMk id="15" creationId="{00000000-0000-0000-0000-000000000000}"/>
          </ac:spMkLst>
        </pc:spChg>
        <pc:spChg chg="mod">
          <ac:chgData name="daniel felipe buitrago" userId="09ce315a97466b30" providerId="LiveId" clId="{CA3A3F9D-8739-4299-B3AA-087EC905EA79}" dt="2025-08-29T21:37:08.577" v="11" actId="14100"/>
          <ac:spMkLst>
            <pc:docMk/>
            <pc:sldMk cId="644688964" sldId="257"/>
            <ac:spMk id="16" creationId="{00000000-0000-0000-0000-000000000000}"/>
          </ac:spMkLst>
        </pc:spChg>
        <pc:spChg chg="mod">
          <ac:chgData name="daniel felipe buitrago" userId="09ce315a97466b30" providerId="LiveId" clId="{CA3A3F9D-8739-4299-B3AA-087EC905EA79}" dt="2025-08-29T21:37:08.577" v="11" actId="14100"/>
          <ac:spMkLst>
            <pc:docMk/>
            <pc:sldMk cId="644688964" sldId="257"/>
            <ac:spMk id="22" creationId="{FE5D0B72-27D1-FAC2-1FCF-418F6E0156F6}"/>
          </ac:spMkLst>
        </pc:spChg>
        <pc:spChg chg="mod">
          <ac:chgData name="daniel felipe buitrago" userId="09ce315a97466b30" providerId="LiveId" clId="{CA3A3F9D-8739-4299-B3AA-087EC905EA79}" dt="2025-08-30T17:46:26.900" v="111" actId="1076"/>
          <ac:spMkLst>
            <pc:docMk/>
            <pc:sldMk cId="644688964" sldId="257"/>
            <ac:spMk id="23" creationId="{A2237435-2D7E-86D6-4A1A-5946081CFFEF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24" creationId="{D33F0C9A-6240-0881-E19F-B6FE74FC7FB0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26" creationId="{8A3D52DB-9AC8-8963-486D-D7430CA15865}"/>
          </ac:spMkLst>
        </pc:spChg>
        <pc:spChg chg="mod">
          <ac:chgData name="daniel felipe buitrago" userId="09ce315a97466b30" providerId="LiveId" clId="{CA3A3F9D-8739-4299-B3AA-087EC905EA79}" dt="2025-08-30T17:38:19.853" v="17" actId="164"/>
          <ac:spMkLst>
            <pc:docMk/>
            <pc:sldMk cId="644688964" sldId="257"/>
            <ac:spMk id="27" creationId="{F1092CF0-A256-3B5B-B589-C12910A661CE}"/>
          </ac:spMkLst>
        </pc:spChg>
        <pc:spChg chg="add del mod">
          <ac:chgData name="daniel felipe buitrago" userId="09ce315a97466b30" providerId="LiveId" clId="{CA3A3F9D-8739-4299-B3AA-087EC905EA79}" dt="2025-08-30T17:40:32.073" v="44" actId="478"/>
          <ac:spMkLst>
            <pc:docMk/>
            <pc:sldMk cId="644688964" sldId="257"/>
            <ac:spMk id="46" creationId="{2EB3922D-F80B-36BC-FBCC-B81F2E2E2B11}"/>
          </ac:spMkLst>
        </pc:spChg>
        <pc:spChg chg="add del mod">
          <ac:chgData name="daniel felipe buitrago" userId="09ce315a97466b30" providerId="LiveId" clId="{CA3A3F9D-8739-4299-B3AA-087EC905EA79}" dt="2025-08-30T17:53:28.266" v="152" actId="478"/>
          <ac:spMkLst>
            <pc:docMk/>
            <pc:sldMk cId="644688964" sldId="257"/>
            <ac:spMk id="47" creationId="{F4E1CCAD-8448-9441-E01A-327703B9BE5B}"/>
          </ac:spMkLst>
        </pc:spChg>
        <pc:spChg chg="add mod">
          <ac:chgData name="daniel felipe buitrago" userId="09ce315a97466b30" providerId="LiveId" clId="{CA3A3F9D-8739-4299-B3AA-087EC905EA79}" dt="2025-08-30T17:54:20.593" v="160" actId="1076"/>
          <ac:spMkLst>
            <pc:docMk/>
            <pc:sldMk cId="644688964" sldId="257"/>
            <ac:spMk id="48" creationId="{24533F96-1DB5-B74B-E54E-2603277B6F8A}"/>
          </ac:spMkLst>
        </pc:spChg>
        <pc:spChg chg="add del mod">
          <ac:chgData name="daniel felipe buitrago" userId="09ce315a97466b30" providerId="LiveId" clId="{CA3A3F9D-8739-4299-B3AA-087EC905EA79}" dt="2025-08-30T17:53:35.091" v="154" actId="478"/>
          <ac:spMkLst>
            <pc:docMk/>
            <pc:sldMk cId="644688964" sldId="257"/>
            <ac:spMk id="49" creationId="{A83E998A-0474-C512-6046-B011B369A24E}"/>
          </ac:spMkLst>
        </pc:spChg>
        <pc:spChg chg="add del mod">
          <ac:chgData name="daniel felipe buitrago" userId="09ce315a97466b30" providerId="LiveId" clId="{CA3A3F9D-8739-4299-B3AA-087EC905EA79}" dt="2025-08-30T17:53:32.240" v="153" actId="478"/>
          <ac:spMkLst>
            <pc:docMk/>
            <pc:sldMk cId="644688964" sldId="257"/>
            <ac:spMk id="50" creationId="{5C3A24C0-43D7-8D43-C4C7-6EFB9C6EC6DB}"/>
          </ac:spMkLst>
        </pc:spChg>
        <pc:spChg chg="add mod">
          <ac:chgData name="daniel felipe buitrago" userId="09ce315a97466b30" providerId="LiveId" clId="{CA3A3F9D-8739-4299-B3AA-087EC905EA79}" dt="2025-08-30T17:56:07.609" v="172" actId="1076"/>
          <ac:spMkLst>
            <pc:docMk/>
            <pc:sldMk cId="644688964" sldId="257"/>
            <ac:spMk id="52" creationId="{7B220BEA-6BFB-5EF7-3B1A-27386B2F6A12}"/>
          </ac:spMkLst>
        </pc:spChg>
        <pc:spChg chg="add del">
          <ac:chgData name="daniel felipe buitrago" userId="09ce315a97466b30" providerId="LiveId" clId="{CA3A3F9D-8739-4299-B3AA-087EC905EA79}" dt="2025-08-30T17:57:12.126" v="176" actId="478"/>
          <ac:spMkLst>
            <pc:docMk/>
            <pc:sldMk cId="644688964" sldId="257"/>
            <ac:spMk id="54" creationId="{9CAD0C9F-106A-A594-162B-AFDDAD9EC6AC}"/>
          </ac:spMkLst>
        </pc:spChg>
        <pc:grpChg chg="mod">
          <ac:chgData name="daniel felipe buitrago" userId="09ce315a97466b30" providerId="LiveId" clId="{CA3A3F9D-8739-4299-B3AA-087EC905EA79}" dt="2025-08-30T17:54:16.967" v="159" actId="1076"/>
          <ac:grpSpMkLst>
            <pc:docMk/>
            <pc:sldMk cId="644688964" sldId="257"/>
            <ac:grpSpMk id="45" creationId="{6801956B-BBE5-E1A1-9AFF-068D7CE648D9}"/>
          </ac:grpSpMkLst>
        </pc:grpChg>
        <pc:picChg chg="mod">
          <ac:chgData name="daniel felipe buitrago" userId="09ce315a97466b30" providerId="LiveId" clId="{CA3A3F9D-8739-4299-B3AA-087EC905EA79}" dt="2025-08-30T17:57:04.413" v="175" actId="1076"/>
          <ac:picMkLst>
            <pc:docMk/>
            <pc:sldMk cId="644688964" sldId="257"/>
            <ac:picMk id="5" creationId="{00000000-0000-0000-0000-000000000000}"/>
          </ac:picMkLst>
        </pc:picChg>
        <pc:picChg chg="mod">
          <ac:chgData name="daniel felipe buitrago" userId="09ce315a97466b30" providerId="LiveId" clId="{CA3A3F9D-8739-4299-B3AA-087EC905EA79}" dt="2025-08-30T17:54:31.348" v="161" actId="1076"/>
          <ac:picMkLst>
            <pc:docMk/>
            <pc:sldMk cId="644688964" sldId="257"/>
            <ac:picMk id="7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40371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94573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24209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21380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02999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65884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83391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18827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46592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559232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73141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3B746-3019-4BE4-8259-A21FE23A1DCB}" type="datetimeFigureOut">
              <a:rPr lang="es-CO" smtClean="0"/>
              <a:t>29/08/2025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0A98B-9681-4547-8908-6BA3D0FF2807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3028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0987" y="101420"/>
            <a:ext cx="6619907" cy="66551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45" name="Agrupar 44">
            <a:extLst>
              <a:ext uri="{FF2B5EF4-FFF2-40B4-BE49-F238E27FC236}">
                <a16:creationId xmlns:a16="http://schemas.microsoft.com/office/drawing/2014/main" id="{6801956B-BBE5-E1A1-9AFF-068D7CE648D9}"/>
              </a:ext>
            </a:extLst>
          </p:cNvPr>
          <p:cNvGrpSpPr/>
          <p:nvPr/>
        </p:nvGrpSpPr>
        <p:grpSpPr>
          <a:xfrm>
            <a:off x="3569970" y="301590"/>
            <a:ext cx="6046966" cy="6388619"/>
            <a:chOff x="779823" y="267362"/>
            <a:chExt cx="6046966" cy="6388619"/>
          </a:xfrm>
        </p:grpSpPr>
        <p:pic>
          <p:nvPicPr>
            <p:cNvPr id="7" name="Imagen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9823" y="267362"/>
              <a:ext cx="549201" cy="573977"/>
            </a:xfrm>
            <a:prstGeom prst="rect">
              <a:avLst/>
            </a:prstGeom>
          </p:spPr>
        </p:pic>
        <p:sp>
          <p:nvSpPr>
            <p:cNvPr id="10" name="Rectángulo 9"/>
            <p:cNvSpPr/>
            <p:nvPr/>
          </p:nvSpPr>
          <p:spPr>
            <a:xfrm>
              <a:off x="4252005" y="5688025"/>
              <a:ext cx="2408974" cy="24328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  <p:sp>
          <p:nvSpPr>
            <p:cNvPr id="11" name="Rectángulo 10"/>
            <p:cNvSpPr/>
            <p:nvPr/>
          </p:nvSpPr>
          <p:spPr>
            <a:xfrm>
              <a:off x="4190170" y="5548055"/>
              <a:ext cx="280846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2800" b="1" dirty="0">
                  <a:solidFill>
                    <a:srgbClr val="FF0000"/>
                  </a:solidFill>
                </a:rPr>
                <a:t>·</a:t>
              </a:r>
              <a:endParaRPr lang="es-CO" sz="2800" dirty="0"/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4330593" y="5669696"/>
              <a:ext cx="24961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100" dirty="0">
                  <a:latin typeface="Segoe UI Variable Text Light" pitchFamily="2" charset="0"/>
                </a:rPr>
                <a:t>Hospital de clínicas veterinarias UFPEL</a:t>
              </a:r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5194611" y="6394371"/>
              <a:ext cx="16321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100" dirty="0">
                  <a:latin typeface="Segoe UI Variable Text Light" pitchFamily="2" charset="0"/>
                </a:rPr>
                <a:t>Fonte: Segoe UI Variable</a:t>
              </a:r>
            </a:p>
          </p:txBody>
        </p:sp>
        <p:pic>
          <p:nvPicPr>
            <p:cNvPr id="14" name="Imagen 13"/>
            <p:cNvPicPr>
              <a:picLocks noChangeAspect="1"/>
            </p:cNvPicPr>
            <p:nvPr/>
          </p:nvPicPr>
          <p:blipFill>
            <a:blip r:embed="rId4">
              <a:clrChange>
                <a:clrFrom>
                  <a:srgbClr val="F2F5EB"/>
                </a:clrFrom>
                <a:clrTo>
                  <a:srgbClr val="F2F5EB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4688594" y="6461747"/>
              <a:ext cx="478988" cy="126857"/>
            </a:xfrm>
            <a:prstGeom prst="rect">
              <a:avLst/>
            </a:prstGeom>
          </p:spPr>
        </p:pic>
        <p:sp>
          <p:nvSpPr>
            <p:cNvPr id="15" name="CuadroTexto 14"/>
            <p:cNvSpPr txBox="1"/>
            <p:nvPr/>
          </p:nvSpPr>
          <p:spPr>
            <a:xfrm>
              <a:off x="779823" y="4135633"/>
              <a:ext cx="86670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100" b="1" dirty="0">
                  <a:latin typeface="Segoe UI Variable Text Light" pitchFamily="2" charset="0"/>
                </a:rPr>
                <a:t>Uruguay</a:t>
              </a:r>
            </a:p>
          </p:txBody>
        </p:sp>
        <p:sp>
          <p:nvSpPr>
            <p:cNvPr id="16" name="Rectángulo 15"/>
            <p:cNvSpPr/>
            <p:nvPr/>
          </p:nvSpPr>
          <p:spPr>
            <a:xfrm>
              <a:off x="5295440" y="4514755"/>
              <a:ext cx="94609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CO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. Pelotas</a:t>
              </a:r>
              <a:endParaRPr lang="es-CO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ángulo 16"/>
            <p:cNvSpPr/>
            <p:nvPr/>
          </p:nvSpPr>
          <p:spPr>
            <a:xfrm>
              <a:off x="5322417" y="4768249"/>
              <a:ext cx="146065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. </a:t>
              </a:r>
              <a:r>
                <a:rPr lang="es-CO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pão</a:t>
              </a:r>
              <a:r>
                <a:rPr lang="es-CO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do Leão</a:t>
              </a:r>
            </a:p>
          </p:txBody>
        </p:sp>
        <p:sp>
          <p:nvSpPr>
            <p:cNvPr id="2" name="Rectángulo 16">
              <a:extLst>
                <a:ext uri="{FF2B5EF4-FFF2-40B4-BE49-F238E27FC236}">
                  <a16:creationId xmlns:a16="http://schemas.microsoft.com/office/drawing/2014/main" id="{DC87F11D-B1F4-72DD-3192-539F1D391036}"/>
                </a:ext>
              </a:extLst>
            </p:cNvPr>
            <p:cNvSpPr/>
            <p:nvPr/>
          </p:nvSpPr>
          <p:spPr>
            <a:xfrm>
              <a:off x="5322417" y="5008450"/>
              <a:ext cx="118654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. Rio Grande</a:t>
              </a:r>
            </a:p>
          </p:txBody>
        </p:sp>
        <p:sp>
          <p:nvSpPr>
            <p:cNvPr id="3" name="Rectángulo 15">
              <a:extLst>
                <a:ext uri="{FF2B5EF4-FFF2-40B4-BE49-F238E27FC236}">
                  <a16:creationId xmlns:a16="http://schemas.microsoft.com/office/drawing/2014/main" id="{0C8E3567-F65B-10D7-D26F-66B0A183FCED}"/>
                </a:ext>
              </a:extLst>
            </p:cNvPr>
            <p:cNvSpPr/>
            <p:nvPr/>
          </p:nvSpPr>
          <p:spPr>
            <a:xfrm>
              <a:off x="5295440" y="4266438"/>
              <a:ext cx="98456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CO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1. </a:t>
              </a:r>
              <a:r>
                <a:rPr lang="es-CO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anguçu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ángulo 15">
              <a:extLst>
                <a:ext uri="{FF2B5EF4-FFF2-40B4-BE49-F238E27FC236}">
                  <a16:creationId xmlns:a16="http://schemas.microsoft.com/office/drawing/2014/main" id="{245A3B96-1EEE-2989-5FD0-042E1BD2939D}"/>
                </a:ext>
              </a:extLst>
            </p:cNvPr>
            <p:cNvSpPr/>
            <p:nvPr/>
          </p:nvSpPr>
          <p:spPr>
            <a:xfrm>
              <a:off x="3425204" y="1659945"/>
              <a:ext cx="359394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100" dirty="0">
                  <a:latin typeface="Segoe UI Variable Text Light" pitchFamily="2" charset="0"/>
                </a:rPr>
                <a:t> </a:t>
              </a:r>
              <a:r>
                <a:rPr lang="es-CO" sz="1100" b="1" dirty="0">
                  <a:latin typeface="Segoe UI Variable Text Light" pitchFamily="2" charset="0"/>
                </a:rPr>
                <a:t> </a:t>
              </a:r>
              <a:r>
                <a:rPr lang="es-CO" sz="1200" b="1" dirty="0">
                  <a:latin typeface="Segoe UI Variable Text Light" pitchFamily="2" charset="0"/>
                </a:rPr>
                <a:t> 1</a:t>
              </a:r>
            </a:p>
          </p:txBody>
        </p:sp>
        <p:sp>
          <p:nvSpPr>
            <p:cNvPr id="9" name="Fluxograma: Conector 8">
              <a:extLst>
                <a:ext uri="{FF2B5EF4-FFF2-40B4-BE49-F238E27FC236}">
                  <a16:creationId xmlns:a16="http://schemas.microsoft.com/office/drawing/2014/main" id="{8C620ABD-5E77-6D14-A1E9-0C266D84C06D}"/>
                </a:ext>
              </a:extLst>
            </p:cNvPr>
            <p:cNvSpPr/>
            <p:nvPr/>
          </p:nvSpPr>
          <p:spPr>
            <a:xfrm>
              <a:off x="3536302" y="1659945"/>
              <a:ext cx="248296" cy="261610"/>
            </a:xfrm>
            <a:prstGeom prst="flowChartConnector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1" name="Rectángulo 15">
              <a:extLst>
                <a:ext uri="{FF2B5EF4-FFF2-40B4-BE49-F238E27FC236}">
                  <a16:creationId xmlns:a16="http://schemas.microsoft.com/office/drawing/2014/main" id="{9B5A9F07-F25D-8D30-DAC1-CCA73B172739}"/>
                </a:ext>
              </a:extLst>
            </p:cNvPr>
            <p:cNvSpPr/>
            <p:nvPr/>
          </p:nvSpPr>
          <p:spPr>
            <a:xfrm>
              <a:off x="3784598" y="2784763"/>
              <a:ext cx="260008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100" b="1" dirty="0">
                  <a:latin typeface="Segoe UI Variable Text Light" pitchFamily="2" charset="0"/>
                </a:rPr>
                <a:t>3</a:t>
              </a:r>
              <a:endParaRPr lang="es-CO" sz="1200" b="1" dirty="0">
                <a:latin typeface="Segoe UI Variable Text Light" pitchFamily="2" charset="0"/>
              </a:endParaRPr>
            </a:p>
          </p:txBody>
        </p:sp>
        <p:sp>
          <p:nvSpPr>
            <p:cNvPr id="22" name="Fluxograma: Conector 21">
              <a:extLst>
                <a:ext uri="{FF2B5EF4-FFF2-40B4-BE49-F238E27FC236}">
                  <a16:creationId xmlns:a16="http://schemas.microsoft.com/office/drawing/2014/main" id="{FE5D0B72-27D1-FAC2-1FCF-418F6E0156F6}"/>
                </a:ext>
              </a:extLst>
            </p:cNvPr>
            <p:cNvSpPr/>
            <p:nvPr/>
          </p:nvSpPr>
          <p:spPr>
            <a:xfrm>
              <a:off x="4088071" y="2381942"/>
              <a:ext cx="224252" cy="250612"/>
            </a:xfrm>
            <a:prstGeom prst="flowChartConnector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pt-BR" dirty="0"/>
            </a:p>
          </p:txBody>
        </p:sp>
        <p:sp>
          <p:nvSpPr>
            <p:cNvPr id="23" name="Rectángulo 15">
              <a:extLst>
                <a:ext uri="{FF2B5EF4-FFF2-40B4-BE49-F238E27FC236}">
                  <a16:creationId xmlns:a16="http://schemas.microsoft.com/office/drawing/2014/main" id="{A2237435-2D7E-86D6-4A1A-5946081CFFEF}"/>
                </a:ext>
              </a:extLst>
            </p:cNvPr>
            <p:cNvSpPr/>
            <p:nvPr/>
          </p:nvSpPr>
          <p:spPr>
            <a:xfrm>
              <a:off x="4067969" y="2381942"/>
              <a:ext cx="224252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s-CO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ángulo 15">
              <a:extLst>
                <a:ext uri="{FF2B5EF4-FFF2-40B4-BE49-F238E27FC236}">
                  <a16:creationId xmlns:a16="http://schemas.microsoft.com/office/drawing/2014/main" id="{D33F0C9A-6240-0881-E19F-B6FE74FC7FB0}"/>
                </a:ext>
              </a:extLst>
            </p:cNvPr>
            <p:cNvSpPr/>
            <p:nvPr/>
          </p:nvSpPr>
          <p:spPr>
            <a:xfrm>
              <a:off x="3881615" y="3763387"/>
              <a:ext cx="29848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CO" sz="1100" dirty="0">
                  <a:latin typeface="Segoe UI Variable Text Light" pitchFamily="2" charset="0"/>
                </a:rPr>
                <a:t> </a:t>
              </a:r>
              <a:r>
                <a:rPr lang="es-CO" sz="1100" b="1" dirty="0">
                  <a:latin typeface="Segoe UI Variable Text Light" pitchFamily="2" charset="0"/>
                </a:rPr>
                <a:t>4</a:t>
              </a:r>
              <a:endParaRPr lang="es-CO" sz="1200" b="1" dirty="0">
                <a:latin typeface="Segoe UI Variable Text Light" pitchFamily="2" charset="0"/>
              </a:endParaRPr>
            </a:p>
          </p:txBody>
        </p:sp>
        <p:sp>
          <p:nvSpPr>
            <p:cNvPr id="26" name="Fluxograma: Conector 25">
              <a:extLst>
                <a:ext uri="{FF2B5EF4-FFF2-40B4-BE49-F238E27FC236}">
                  <a16:creationId xmlns:a16="http://schemas.microsoft.com/office/drawing/2014/main" id="{8A3D52DB-9AC8-8963-486D-D7430CA15865}"/>
                </a:ext>
              </a:extLst>
            </p:cNvPr>
            <p:cNvSpPr/>
            <p:nvPr/>
          </p:nvSpPr>
          <p:spPr>
            <a:xfrm>
              <a:off x="3806603" y="2784763"/>
              <a:ext cx="224252" cy="250612"/>
            </a:xfrm>
            <a:prstGeom prst="flowChartConnector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pt-BR" dirty="0"/>
            </a:p>
          </p:txBody>
        </p:sp>
        <p:sp>
          <p:nvSpPr>
            <p:cNvPr id="27" name="Fluxograma: Conector 26">
              <a:extLst>
                <a:ext uri="{FF2B5EF4-FFF2-40B4-BE49-F238E27FC236}">
                  <a16:creationId xmlns:a16="http://schemas.microsoft.com/office/drawing/2014/main" id="{F1092CF0-A256-3B5B-B589-C12910A661CE}"/>
                </a:ext>
              </a:extLst>
            </p:cNvPr>
            <p:cNvSpPr/>
            <p:nvPr/>
          </p:nvSpPr>
          <p:spPr>
            <a:xfrm>
              <a:off x="3939885" y="3768886"/>
              <a:ext cx="224252" cy="250612"/>
            </a:xfrm>
            <a:prstGeom prst="flowChartConnector">
              <a:avLst/>
            </a:prstGeom>
            <a:noFill/>
            <a:ln w="9525" cap="flat" cmpd="sng" algn="ctr">
              <a:solidFill>
                <a:schemeClr val="dk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pt-BR" dirty="0"/>
            </a:p>
          </p:txBody>
        </p:sp>
      </p:grpSp>
      <p:sp>
        <p:nvSpPr>
          <p:cNvPr id="43" name="Rectangle 1">
            <a:extLst>
              <a:ext uri="{FF2B5EF4-FFF2-40B4-BE49-F238E27FC236}">
                <a16:creationId xmlns:a16="http://schemas.microsoft.com/office/drawing/2014/main" id="{E5B46372-0FBD-6C08-33D9-2649480A67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/>
          </a:p>
        </p:txBody>
      </p:sp>
      <p:sp>
        <p:nvSpPr>
          <p:cNvPr id="48" name="Rectángulo 15">
            <a:extLst>
              <a:ext uri="{FF2B5EF4-FFF2-40B4-BE49-F238E27FC236}">
                <a16:creationId xmlns:a16="http://schemas.microsoft.com/office/drawing/2014/main" id="{24533F96-1DB5-B74B-E54E-2603277B6F8A}"/>
              </a:ext>
            </a:extLst>
          </p:cNvPr>
          <p:cNvSpPr/>
          <p:nvPr/>
        </p:nvSpPr>
        <p:spPr>
          <a:xfrm>
            <a:off x="8346358" y="3469280"/>
            <a:ext cx="137064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CO" sz="1100" b="1" dirty="0">
                <a:latin typeface="Arial" panose="020B0604020202020204" pitchFamily="34" charset="0"/>
                <a:cs typeface="Arial" panose="020B0604020202020204" pitchFamily="34" charset="0"/>
              </a:rPr>
              <a:t>Atlantic </a:t>
            </a:r>
            <a:r>
              <a:rPr lang="es-CO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Ocean</a:t>
            </a:r>
            <a:r>
              <a:rPr lang="es-CO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2" name="CaixaDeTexto 51">
            <a:extLst>
              <a:ext uri="{FF2B5EF4-FFF2-40B4-BE49-F238E27FC236}">
                <a16:creationId xmlns:a16="http://schemas.microsoft.com/office/drawing/2014/main" id="{7B220BEA-6BFB-5EF7-3B1A-27386B2F6A12}"/>
              </a:ext>
            </a:extLst>
          </p:cNvPr>
          <p:cNvSpPr txBox="1"/>
          <p:nvPr/>
        </p:nvSpPr>
        <p:spPr>
          <a:xfrm>
            <a:off x="954545" y="1315621"/>
            <a:ext cx="609755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uth of the state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io Grande do Sul</a:t>
            </a:r>
            <a:endParaRPr lang="pt-B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46889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6</TotalTime>
  <Words>4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egoe UI Variable Text Light</vt:lpstr>
      <vt:lpstr>Tema de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hon Alexander Tobar Ledezma</dc:creator>
  <cp:lastModifiedBy>daniel felipe buitrago</cp:lastModifiedBy>
  <cp:revision>10</cp:revision>
  <dcterms:created xsi:type="dcterms:W3CDTF">2025-08-09T13:04:50Z</dcterms:created>
  <dcterms:modified xsi:type="dcterms:W3CDTF">2025-08-30T21:47:29Z</dcterms:modified>
</cp:coreProperties>
</file>